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A82282-CC7A-114E-10B3-A5D7C4F294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4794A4A-A0C2-31A6-2B2A-9D82634AD9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876ADF4-EA7B-8BCA-04BB-164C850E3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051F2C-EF46-3A2A-F4D8-099C7AB43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CFD724-4AA3-35C1-15BD-6A02013CF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3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D53CCE-6960-5F45-24B2-FF5EB8F5C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C180E04-5A08-A607-2E18-06AA871732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0B9D1BC-0CBF-9543-10A7-2459D52D9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B5FE0A-5C81-5F2D-DBCE-97992DD38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9A1D08-EF7E-01EC-B736-B5C4415C4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985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25C6681-5A43-4580-5B4E-EC3C865C84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9DFA1C5-C722-65E3-9829-68300580DD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2EE20F-822B-B390-F87B-9BE44AB56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46B4CF-6534-DD91-9180-3820EB3B6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70040E-4F0E-B00A-62E6-FBE9CFC51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03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1DDEF1-C2D2-ECDD-C89B-DA51BAD63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983DB13-AB64-FF12-D3F0-7C4853E4F1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42917C-E5C7-BD23-2EB4-95A60B447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872148-6DF3-1D43-7956-70292CE04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0D292A-F18E-94DC-40EF-2A54D8459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051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812737-864A-8F3E-7D65-1C1BBF115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28E4447-8D14-119B-7083-DDC16C54B0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8797FA-C829-B186-CEF7-E1B8AB33F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5A965F-F5F5-0295-038A-BFE844616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F8176A-D20D-135E-BBE2-00B156AD4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568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471119-ED47-CC3C-A28D-F9EAA366D9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AA698F8-563E-78D5-31BA-D671AB0979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329E980-6FF2-3403-1D05-5C46C981A2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CDF6092-BD1B-C955-3B94-FB46369F9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3593828-3436-CA1E-937F-FB7B21AD9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6F943D4-933A-A824-D23A-32491B2FC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20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A713CB-CF86-9441-8E5F-C6F3098F15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3561B1-FE47-F5C6-1C06-EAAA0021CB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1200C3-65A0-D767-6F5A-CD617A32D3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BE7B79A-8075-4EDA-2C6A-3FA117CBFC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FAE31AC-F0AD-C221-1D8F-15B8CC2BB0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685C64B-61EF-D55E-7159-711F6E759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F51AEC8-F397-4013-8AA2-B625F4125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3D07048-D6DB-6CC3-3F8A-774067469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464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D0A4E2-319A-7512-241D-8BBCC4226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CADF80D-3677-F095-7B0E-68060ED83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CD9B174-E569-1B52-B3F8-ED0A30FFE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68966B3-419F-1FFB-0102-EED642CA4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798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3D35B72-8044-646D-68E9-348315116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570993B-DA0E-0563-1CBE-C155A166B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3375E3F-4083-9406-6E3B-FE80134D7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287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81AB50-15A8-B1D0-A89E-2447B221B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22CD383-76B4-FA84-3FB0-D26BE7439D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FF148E-166C-44EB-14C1-1CF37FA901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F610451-2618-F1B4-F7FA-060E98051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7E0750-6C88-127A-2D36-07CB1CD33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340032C-CBC2-CFA7-332C-182BFD8F4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930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F55CAD-EE22-8E58-0547-FF9E66D7B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C66C654-4C3D-77EC-8D4D-86682EC67B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354E8B-507B-B5A7-2BBC-626521EAD9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8232C1-9B38-84BC-ADE8-FB47FB0FF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44DB8C-034E-618F-9DD9-413B8B74C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EA85F7-39BD-7C5B-F5A8-44B3EB19D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9644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2C226E1-3FCB-8F93-5D28-DD9E3DFBE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5C913CB-CB1A-00DF-81E9-3B75A2F71D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133CA0-8436-5239-F548-5024D34605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7ACBA4D-1BB7-7144-B291-8B6DC5C62C6E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FA6F30-EA26-A584-998C-53D86599EA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A570C9-8D88-2070-5F2A-C7A120C65D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0A181A-F876-E44D-BAE2-BF6B285AE9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1571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72D9B551-17F4-EC40-0E68-5C56B89655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6000" y="1824312"/>
            <a:ext cx="3600000" cy="3600000"/>
          </a:xfrm>
          <a:prstGeom prst="rect">
            <a:avLst/>
          </a:prstGeom>
        </p:spPr>
      </p:pic>
      <p:pic>
        <p:nvPicPr>
          <p:cNvPr id="24" name="図 23" descr="グラフ, 箱ひげ図&#10;&#10;AI 生成コンテンツは誤りを含む可能性があります。">
            <a:extLst>
              <a:ext uri="{FF2B5EF4-FFF2-40B4-BE49-F238E27FC236}">
                <a16:creationId xmlns:a16="http://schemas.microsoft.com/office/drawing/2014/main" id="{FB762163-53DB-7ABC-60AE-B75A2C9F17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76945" y="1824312"/>
            <a:ext cx="3600000" cy="360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80F2C8C-95AC-0C86-3122-039A769D10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8723" y="5064311"/>
            <a:ext cx="2952657" cy="389973"/>
          </a:xfrm>
          <a:prstGeom prst="rect">
            <a:avLst/>
          </a:prstGeom>
        </p:spPr>
      </p:pic>
      <p:pic>
        <p:nvPicPr>
          <p:cNvPr id="6" name="図 5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9709DAA6-684E-CD1B-1772-63F3AB2C63A2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15055" y="1824312"/>
            <a:ext cx="3600000" cy="3240000"/>
          </a:xfrm>
          <a:prstGeom prst="rect">
            <a:avLst/>
          </a:prstGeom>
        </p:spPr>
      </p:pic>
      <p:sp>
        <p:nvSpPr>
          <p:cNvPr id="2" name="タイトル 1">
            <a:extLst>
              <a:ext uri="{FF2B5EF4-FFF2-40B4-BE49-F238E27FC236}">
                <a16:creationId xmlns:a16="http://schemas.microsoft.com/office/drawing/2014/main" id="{AC885B89-3537-2BB2-751F-16A04C677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r>
              <a:rPr kumimoji="1"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Figure S5.</a:t>
            </a:r>
            <a:endParaRPr kumimoji="1"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14D5BDC-98F2-61B4-1EDE-E5B99B8A21F1}"/>
              </a:ext>
            </a:extLst>
          </p:cNvPr>
          <p:cNvSpPr txBox="1"/>
          <p:nvPr/>
        </p:nvSpPr>
        <p:spPr>
          <a:xfrm>
            <a:off x="1331285" y="4925812"/>
            <a:ext cx="1767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rastuzumab treatmen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 2">
            <a:extLst>
              <a:ext uri="{FF2B5EF4-FFF2-40B4-BE49-F238E27FC236}">
                <a16:creationId xmlns:a16="http://schemas.microsoft.com/office/drawing/2014/main" id="{88D905F8-65FC-E575-AA95-B9D84CE392FF}"/>
              </a:ext>
            </a:extLst>
          </p:cNvPr>
          <p:cNvGraphicFramePr>
            <a:graphicFrameLocks noGrp="1"/>
          </p:cNvGraphicFramePr>
          <p:nvPr/>
        </p:nvGraphicFramePr>
        <p:xfrm>
          <a:off x="9568079" y="2015896"/>
          <a:ext cx="2210044" cy="968399"/>
        </p:xfrm>
        <a:graphic>
          <a:graphicData uri="http://schemas.openxmlformats.org/drawingml/2006/table">
            <a:tbl>
              <a:tblPr firstRow="1" bandRow="1"/>
              <a:tblGrid>
                <a:gridCol w="989575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397827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822642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-homo (n=4)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6-NA)</a:t>
                      </a: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-hetero (n=4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-NA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graphicFrame>
        <p:nvGraphicFramePr>
          <p:cNvPr id="7" name="表 2">
            <a:extLst>
              <a:ext uri="{FF2B5EF4-FFF2-40B4-BE49-F238E27FC236}">
                <a16:creationId xmlns:a16="http://schemas.microsoft.com/office/drawing/2014/main" id="{296320B1-B880-AC19-F564-AA519522C2B1}"/>
              </a:ext>
            </a:extLst>
          </p:cNvPr>
          <p:cNvGraphicFramePr>
            <a:graphicFrameLocks noGrp="1"/>
          </p:cNvGraphicFramePr>
          <p:nvPr/>
        </p:nvGraphicFramePr>
        <p:xfrm>
          <a:off x="5667105" y="1977956"/>
          <a:ext cx="2229484" cy="1006339"/>
        </p:xfrm>
        <a:graphic>
          <a:graphicData uri="http://schemas.openxmlformats.org/drawingml/2006/table">
            <a:tbl>
              <a:tblPr firstRow="1" bandRow="1"/>
              <a:tblGrid>
                <a:gridCol w="1009015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397827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822642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-homo (n=4)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5-NA)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-hetero (n=4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-NA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82F4B58-11E5-B52C-7CAD-1828C64E5C70}"/>
              </a:ext>
            </a:extLst>
          </p:cNvPr>
          <p:cNvSpPr txBox="1"/>
          <p:nvPr/>
        </p:nvSpPr>
        <p:spPr>
          <a:xfrm>
            <a:off x="4296000" y="179827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9D02F0A8-8011-C0C4-CE19-FA73D519A7D8}"/>
              </a:ext>
            </a:extLst>
          </p:cNvPr>
          <p:cNvCxnSpPr/>
          <p:nvPr/>
        </p:nvCxnSpPr>
        <p:spPr>
          <a:xfrm>
            <a:off x="5534023" y="281285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6358B0B2-7CA5-9B97-C881-B01B4E13319D}"/>
              </a:ext>
            </a:extLst>
          </p:cNvPr>
          <p:cNvCxnSpPr>
            <a:cxnSpLocks/>
          </p:cNvCxnSpPr>
          <p:nvPr/>
        </p:nvCxnSpPr>
        <p:spPr>
          <a:xfrm>
            <a:off x="5534023" y="2471170"/>
            <a:ext cx="144000" cy="0"/>
          </a:xfrm>
          <a:prstGeom prst="line">
            <a:avLst/>
          </a:prstGeom>
          <a:ln w="19050">
            <a:solidFill>
              <a:srgbClr val="E0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758F525-5042-2C12-FE6B-F62942E04271}"/>
              </a:ext>
            </a:extLst>
          </p:cNvPr>
          <p:cNvSpPr txBox="1"/>
          <p:nvPr/>
        </p:nvSpPr>
        <p:spPr>
          <a:xfrm>
            <a:off x="6919451" y="2984295"/>
            <a:ext cx="9765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p=0.17</a:t>
            </a: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AB5107A4-D113-7DB0-EB47-5B3B93DA3F7D}"/>
              </a:ext>
            </a:extLst>
          </p:cNvPr>
          <p:cNvCxnSpPr/>
          <p:nvPr/>
        </p:nvCxnSpPr>
        <p:spPr>
          <a:xfrm>
            <a:off x="9429866" y="2812988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3111E028-CFFB-A7E4-8B2C-6F63F64A9286}"/>
              </a:ext>
            </a:extLst>
          </p:cNvPr>
          <p:cNvCxnSpPr>
            <a:cxnSpLocks/>
          </p:cNvCxnSpPr>
          <p:nvPr/>
        </p:nvCxnSpPr>
        <p:spPr>
          <a:xfrm>
            <a:off x="9424079" y="2500095"/>
            <a:ext cx="144000" cy="0"/>
          </a:xfrm>
          <a:prstGeom prst="line">
            <a:avLst/>
          </a:prstGeom>
          <a:ln w="19050">
            <a:solidFill>
              <a:srgbClr val="E0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41A2FAF-B908-9CF3-4B27-BE2DB3DE8665}"/>
              </a:ext>
            </a:extLst>
          </p:cNvPr>
          <p:cNvSpPr txBox="1"/>
          <p:nvPr/>
        </p:nvSpPr>
        <p:spPr>
          <a:xfrm>
            <a:off x="10800396" y="2984295"/>
            <a:ext cx="9765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p=0.03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F159C61-1123-C65D-4414-3FDF28FAD69D}"/>
              </a:ext>
            </a:extLst>
          </p:cNvPr>
          <p:cNvSpPr txBox="1"/>
          <p:nvPr/>
        </p:nvSpPr>
        <p:spPr>
          <a:xfrm>
            <a:off x="8179300" y="1798277"/>
            <a:ext cx="282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F864418-F597-06D6-E0FE-AEF1E1A212B5}"/>
              </a:ext>
            </a:extLst>
          </p:cNvPr>
          <p:cNvSpPr txBox="1"/>
          <p:nvPr/>
        </p:nvSpPr>
        <p:spPr>
          <a:xfrm>
            <a:off x="412700" y="179827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7740A1C-3BBE-DA42-8C5C-9DB6B9D61BE9}"/>
              </a:ext>
            </a:extLst>
          </p:cNvPr>
          <p:cNvSpPr txBox="1"/>
          <p:nvPr/>
        </p:nvSpPr>
        <p:spPr>
          <a:xfrm rot="16200000">
            <a:off x="3766268" y="3322922"/>
            <a:ext cx="151035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CBF61CE-0D39-35AD-C62C-F8D4F186E952}"/>
              </a:ext>
            </a:extLst>
          </p:cNvPr>
          <p:cNvSpPr txBox="1"/>
          <p:nvPr/>
        </p:nvSpPr>
        <p:spPr>
          <a:xfrm rot="16200000">
            <a:off x="7882062" y="3324982"/>
            <a:ext cx="107433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ECA419B-618F-EEB5-A7CE-654D2F3E2CFD}"/>
              </a:ext>
            </a:extLst>
          </p:cNvPr>
          <p:cNvSpPr txBox="1"/>
          <p:nvPr/>
        </p:nvSpPr>
        <p:spPr>
          <a:xfrm>
            <a:off x="5968261" y="4908781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00C3C9C-941A-7359-17C2-ED22DDB3CF2D}"/>
              </a:ext>
            </a:extLst>
          </p:cNvPr>
          <p:cNvSpPr txBox="1"/>
          <p:nvPr/>
        </p:nvSpPr>
        <p:spPr>
          <a:xfrm>
            <a:off x="9835281" y="4908781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B41C959-CF41-1844-1CCF-F3C602099A37}"/>
              </a:ext>
            </a:extLst>
          </p:cNvPr>
          <p:cNvSpPr txBox="1"/>
          <p:nvPr/>
        </p:nvSpPr>
        <p:spPr>
          <a:xfrm rot="16200000">
            <a:off x="-489178" y="3290500"/>
            <a:ext cx="217880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R2-positive proportion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5363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Macintosh PowerPoint</Application>
  <PresentationFormat>ワイド画面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Figure S5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吉野光一郎</dc:creator>
  <cp:lastModifiedBy>Koichiro Yoshino</cp:lastModifiedBy>
  <cp:revision>2</cp:revision>
  <dcterms:created xsi:type="dcterms:W3CDTF">2025-11-04T04:59:47Z</dcterms:created>
  <dcterms:modified xsi:type="dcterms:W3CDTF">2026-02-24T02:36:39Z</dcterms:modified>
</cp:coreProperties>
</file>